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53" d="100"/>
          <a:sy n="53" d="100"/>
        </p:scale>
        <p:origin x="-78" y="-13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9937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44800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140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574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72734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9981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26293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018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40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491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097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9F9DC-6137-4FD5-9D74-BE163F30739A}" type="datetimeFigureOut">
              <a:rPr lang="en-AU" smtClean="0"/>
              <a:t>18/09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A9DF2D-C5CA-4E05-BCC6-433AA0159B7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2408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2422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1</a:t>
            </a:r>
            <a:endParaRPr lang="en-AU" sz="20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00110"/>
            <a:ext cx="6080026" cy="303264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80026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2</a:t>
            </a:r>
            <a:endParaRPr lang="en-AU" sz="2000" dirty="0"/>
          </a:p>
        </p:txBody>
      </p:sp>
      <p:pic>
        <p:nvPicPr>
          <p:cNvPr id="9" name="Picture 8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080026" y="405362"/>
            <a:ext cx="6080400" cy="303264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22421" y="343275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3</a:t>
            </a:r>
            <a:endParaRPr lang="en-AU" sz="2000" dirty="0"/>
          </a:p>
        </p:txBody>
      </p:sp>
      <p:pic>
        <p:nvPicPr>
          <p:cNvPr id="11" name="Picture 10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832860"/>
            <a:ext cx="6080400" cy="30312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6080026" y="3427498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4</a:t>
            </a:r>
            <a:endParaRPr lang="en-AU" sz="2000" dirty="0"/>
          </a:p>
        </p:txBody>
      </p:sp>
      <p:pic>
        <p:nvPicPr>
          <p:cNvPr id="13" name="Picture 12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076073" y="3827608"/>
            <a:ext cx="6080400" cy="3032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543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2422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5</a:t>
            </a:r>
            <a:endParaRPr lang="en-AU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6080026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6</a:t>
            </a:r>
            <a:endParaRPr lang="en-AU" sz="2000" dirty="0"/>
          </a:p>
        </p:txBody>
      </p:sp>
      <p:sp>
        <p:nvSpPr>
          <p:cNvPr id="8" name="TextBox 7"/>
          <p:cNvSpPr txBox="1"/>
          <p:nvPr/>
        </p:nvSpPr>
        <p:spPr>
          <a:xfrm>
            <a:off x="222421" y="343275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7</a:t>
            </a:r>
            <a:endParaRPr lang="en-AU" sz="2000" dirty="0"/>
          </a:p>
        </p:txBody>
      </p:sp>
      <p:sp>
        <p:nvSpPr>
          <p:cNvPr id="9" name="TextBox 8"/>
          <p:cNvSpPr txBox="1"/>
          <p:nvPr/>
        </p:nvSpPr>
        <p:spPr>
          <a:xfrm>
            <a:off x="6080026" y="3427498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8</a:t>
            </a:r>
            <a:endParaRPr lang="en-AU" sz="2000" dirty="0"/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94858"/>
            <a:ext cx="6080400" cy="3031200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080026" y="397006"/>
            <a:ext cx="6080400" cy="3031200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820916"/>
            <a:ext cx="6080400" cy="3031200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080026" y="3819370"/>
            <a:ext cx="6080400" cy="3032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6393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080026" y="407628"/>
            <a:ext cx="6080400" cy="3031200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00110"/>
            <a:ext cx="6080400" cy="30312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22422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9</a:t>
            </a:r>
            <a:endParaRPr lang="en-AU" sz="2000" dirty="0"/>
          </a:p>
        </p:txBody>
      </p:sp>
      <p:sp>
        <p:nvSpPr>
          <p:cNvPr id="8" name="TextBox 7"/>
          <p:cNvSpPr txBox="1"/>
          <p:nvPr/>
        </p:nvSpPr>
        <p:spPr>
          <a:xfrm>
            <a:off x="6080026" y="0"/>
            <a:ext cx="165580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2000" dirty="0" smtClean="0"/>
              <a:t>Participant 10</a:t>
            </a:r>
            <a:endParaRPr lang="en-AU" sz="2000" dirty="0"/>
          </a:p>
        </p:txBody>
      </p:sp>
      <p:sp>
        <p:nvSpPr>
          <p:cNvPr id="6" name="TextBox 5"/>
          <p:cNvSpPr txBox="1"/>
          <p:nvPr/>
        </p:nvSpPr>
        <p:spPr>
          <a:xfrm>
            <a:off x="434167" y="3831420"/>
            <a:ext cx="111548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S1 Figs</a:t>
            </a:r>
            <a:endParaRPr lang="en-AU" dirty="0"/>
          </a:p>
          <a:p>
            <a:r>
              <a:rPr lang="en-AU" dirty="0"/>
              <a:t>Results for Participants 1 </a:t>
            </a:r>
            <a:r>
              <a:rPr lang="en-AU"/>
              <a:t>through </a:t>
            </a:r>
            <a:r>
              <a:rPr lang="en-AU" smtClean="0"/>
              <a:t>10.  Position </a:t>
            </a:r>
            <a:r>
              <a:rPr lang="en-AU" dirty="0"/>
              <a:t>of spinous processes (</a:t>
            </a:r>
            <a:r>
              <a:rPr lang="en-AU" dirty="0" smtClean="0"/>
              <a:t>Blue) </a:t>
            </a:r>
            <a:r>
              <a:rPr lang="en-AU" dirty="0"/>
              <a:t>and surface fiducial markers (Red), viewed in the sagittal </a:t>
            </a:r>
            <a:r>
              <a:rPr lang="en-AU" dirty="0" smtClean="0"/>
              <a:t>plane. The unbroken lines indicate the 7</a:t>
            </a:r>
            <a:r>
              <a:rPr lang="en-AU" baseline="30000" dirty="0" smtClean="0"/>
              <a:t>th</a:t>
            </a:r>
            <a:r>
              <a:rPr lang="en-AU" dirty="0" smtClean="0"/>
              <a:t> order polynomial fit to the marker points. (Note: for participant 7, the Anterior-posterior co-ordinate system was flipped.)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55482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3</TotalTime>
  <Words>77</Words>
  <Application>Microsoft Office PowerPoint</Application>
  <PresentationFormat>Custom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Queensland University of Techn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ige Little</dc:creator>
  <cp:lastModifiedBy>Maree Izatt</cp:lastModifiedBy>
  <cp:revision>6</cp:revision>
  <dcterms:created xsi:type="dcterms:W3CDTF">2018-11-14T03:45:45Z</dcterms:created>
  <dcterms:modified xsi:type="dcterms:W3CDTF">2019-09-18T04:39:02Z</dcterms:modified>
</cp:coreProperties>
</file>